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6"/>
  </p:notesMasterIdLst>
  <p:sldIdLst>
    <p:sldId id="256" r:id="rId2"/>
    <p:sldId id="257" r:id="rId3"/>
    <p:sldId id="262" r:id="rId4"/>
    <p:sldId id="263" r:id="rId5"/>
  </p:sldIdLst>
  <p:sldSz cx="12192000" cy="16256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970"/>
    <p:restoredTop sz="94271"/>
  </p:normalViewPr>
  <p:slideViewPr>
    <p:cSldViewPr snapToGrid="0" snapToObjects="1">
      <p:cViewPr varScale="1">
        <p:scale>
          <a:sx n="29" d="100"/>
          <a:sy n="29" d="100"/>
        </p:scale>
        <p:origin x="217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4F46DDF-32A0-BF45-BE9D-EDAFC03681F1}" type="datetimeFigureOut">
              <a:rPr lang="en-US" smtClean="0"/>
              <a:t>10/31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1176491-42B6-BC4A-9CC7-EEBA889C1F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28775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1176491-42B6-BC4A-9CC7-EEBA889C1FE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39148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162FD-50C5-C841-99C7-7CAD1A3CB373}" type="datetimeFigureOut">
              <a:rPr lang="en-US" smtClean="0"/>
              <a:t>10/3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E9E05-D3D6-A24C-AF4E-CBEF828D3D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65670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162FD-50C5-C841-99C7-7CAD1A3CB373}" type="datetimeFigureOut">
              <a:rPr lang="en-US" smtClean="0"/>
              <a:t>10/3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E9E05-D3D6-A24C-AF4E-CBEF828D3D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10704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162FD-50C5-C841-99C7-7CAD1A3CB373}" type="datetimeFigureOut">
              <a:rPr lang="en-US" smtClean="0"/>
              <a:t>10/3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E9E05-D3D6-A24C-AF4E-CBEF828D3D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83867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162FD-50C5-C841-99C7-7CAD1A3CB373}" type="datetimeFigureOut">
              <a:rPr lang="en-US" smtClean="0"/>
              <a:t>10/3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E9E05-D3D6-A24C-AF4E-CBEF828D3D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21054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162FD-50C5-C841-99C7-7CAD1A3CB373}" type="datetimeFigureOut">
              <a:rPr lang="en-US" smtClean="0"/>
              <a:t>10/3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E9E05-D3D6-A24C-AF4E-CBEF828D3D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56954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162FD-50C5-C841-99C7-7CAD1A3CB373}" type="datetimeFigureOut">
              <a:rPr lang="en-US" smtClean="0"/>
              <a:t>10/3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E9E05-D3D6-A24C-AF4E-CBEF828D3D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05273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162FD-50C5-C841-99C7-7CAD1A3CB373}" type="datetimeFigureOut">
              <a:rPr lang="en-US" smtClean="0"/>
              <a:t>10/31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E9E05-D3D6-A24C-AF4E-CBEF828D3D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71166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162FD-50C5-C841-99C7-7CAD1A3CB373}" type="datetimeFigureOut">
              <a:rPr lang="en-US" smtClean="0"/>
              <a:t>10/31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E9E05-D3D6-A24C-AF4E-CBEF828D3D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12043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162FD-50C5-C841-99C7-7CAD1A3CB373}" type="datetimeFigureOut">
              <a:rPr lang="en-US" smtClean="0"/>
              <a:t>10/31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E9E05-D3D6-A24C-AF4E-CBEF828D3D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95286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162FD-50C5-C841-99C7-7CAD1A3CB373}" type="datetimeFigureOut">
              <a:rPr lang="en-US" smtClean="0"/>
              <a:t>10/3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E9E05-D3D6-A24C-AF4E-CBEF828D3D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33110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162FD-50C5-C841-99C7-7CAD1A3CB373}" type="datetimeFigureOut">
              <a:rPr lang="en-US" smtClean="0"/>
              <a:t>10/3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E9E05-D3D6-A24C-AF4E-CBEF828D3D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97465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A162FD-50C5-C841-99C7-7CAD1A3CB373}" type="datetimeFigureOut">
              <a:rPr lang="en-US" smtClean="0"/>
              <a:t>10/3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FE9E05-D3D6-A24C-AF4E-CBEF828D3D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79842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g"/><Relationship Id="rId5" Type="http://schemas.openxmlformats.org/officeDocument/2006/relationships/image" Target="../media/image3.jpg"/><Relationship Id="rId4" Type="http://schemas.openxmlformats.org/officeDocument/2006/relationships/image" Target="../media/image2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jpg"/><Relationship Id="rId4" Type="http://schemas.openxmlformats.org/officeDocument/2006/relationships/image" Target="../media/image7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g"/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jpg"/><Relationship Id="rId4" Type="http://schemas.openxmlformats.org/officeDocument/2006/relationships/image" Target="../media/image11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g"/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6.jpg"/><Relationship Id="rId4" Type="http://schemas.openxmlformats.org/officeDocument/2006/relationships/image" Target="../media/image15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>
            <a:extLst>
              <a:ext uri="{FF2B5EF4-FFF2-40B4-BE49-F238E27FC236}">
                <a16:creationId xmlns:a16="http://schemas.microsoft.com/office/drawing/2014/main" id="{97A6ABFC-0155-4E4F-BE70-A77006C5F5A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9709" y="1682783"/>
            <a:ext cx="5760000" cy="576000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B3B54BC7-460D-5E48-BCF6-E56C8455DAC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226615" y="1682783"/>
            <a:ext cx="5760000" cy="576000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C8ED21EB-ACF3-144A-944F-88A239FCFBA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99709" y="8083583"/>
            <a:ext cx="5760000" cy="576000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85D8D761-7F73-CA4C-81DC-6D38C608992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226615" y="8083583"/>
            <a:ext cx="5760000" cy="5760000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54D168D8-29B8-5B4C-B4AE-18E69FC43ABE}"/>
              </a:ext>
            </a:extLst>
          </p:cNvPr>
          <p:cNvSpPr txBox="1"/>
          <p:nvPr/>
        </p:nvSpPr>
        <p:spPr>
          <a:xfrm>
            <a:off x="399709" y="1325247"/>
            <a:ext cx="2632003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600" b="1" dirty="0"/>
              <a:t>9-days-old larvae 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3804942-B99A-D849-B58B-BC15D8641505}"/>
              </a:ext>
            </a:extLst>
          </p:cNvPr>
          <p:cNvSpPr txBox="1"/>
          <p:nvPr/>
        </p:nvSpPr>
        <p:spPr>
          <a:xfrm>
            <a:off x="6190615" y="1325247"/>
            <a:ext cx="2495683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600" b="1" dirty="0"/>
              <a:t>0-day-old adults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AD9D1B1-CF01-824D-B787-99F49FD8E01C}"/>
              </a:ext>
            </a:extLst>
          </p:cNvPr>
          <p:cNvSpPr txBox="1"/>
          <p:nvPr/>
        </p:nvSpPr>
        <p:spPr>
          <a:xfrm>
            <a:off x="399709" y="7684483"/>
            <a:ext cx="2707664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600" b="1" dirty="0"/>
              <a:t>7-days-old adults  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D3BFA019-5862-6640-BD9F-FC51FF5B949D}"/>
              </a:ext>
            </a:extLst>
          </p:cNvPr>
          <p:cNvSpPr txBox="1"/>
          <p:nvPr/>
        </p:nvSpPr>
        <p:spPr>
          <a:xfrm>
            <a:off x="6190615" y="7684483"/>
            <a:ext cx="2800638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600" b="1" dirty="0"/>
              <a:t>14-days-old adults 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EB88DD40-7862-8449-A3BB-73E05B099E9C}"/>
              </a:ext>
            </a:extLst>
          </p:cNvPr>
          <p:cNvSpPr txBox="1"/>
          <p:nvPr/>
        </p:nvSpPr>
        <p:spPr>
          <a:xfrm>
            <a:off x="-6171" y="488674"/>
            <a:ext cx="40588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dirty="0"/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25680380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0710A5E0-8316-204D-B31A-B6ACFF04E2C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3600" y="1692788"/>
            <a:ext cx="5760000" cy="57600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0CE52C1-E6DE-EA4A-886B-74C348023CF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9714" y="1692788"/>
            <a:ext cx="5760000" cy="57600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AB77CC48-9495-CE4F-A8EC-6E3FAB91D45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3600" y="8072806"/>
            <a:ext cx="5760000" cy="576000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5CC23503-4B2D-3345-84A1-0D9C3A2963D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99714" y="8072806"/>
            <a:ext cx="5760000" cy="5760000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6719C6AD-6273-0A41-A124-10B7DA10149E}"/>
              </a:ext>
            </a:extLst>
          </p:cNvPr>
          <p:cNvSpPr txBox="1"/>
          <p:nvPr/>
        </p:nvSpPr>
        <p:spPr>
          <a:xfrm>
            <a:off x="658090" y="14131636"/>
            <a:ext cx="10931237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Supplementary Figure S1. GO enrichment analysis of top 10 enriched GO terms of a. up-regulated and b. down-regulated DEGs among different imidacloprid treatments at 9-days-old larvae, 0-day-old adults, 7-days-old adults, and 14-days-old adults. Count: the numbers of DEGs; </a:t>
            </a:r>
            <a:r>
              <a:rPr lang="en-US" sz="2400" dirty="0" err="1"/>
              <a:t>p.adjust</a:t>
            </a:r>
            <a:r>
              <a:rPr lang="en-US" sz="2400" dirty="0"/>
              <a:t>: the adjusted p value of identified GO term. Bar color from red to blue representing the adjusted p value from low to high.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D46A5781-6B6F-0944-B32A-71D9F8B668C3}"/>
              </a:ext>
            </a:extLst>
          </p:cNvPr>
          <p:cNvSpPr/>
          <p:nvPr/>
        </p:nvSpPr>
        <p:spPr>
          <a:xfrm>
            <a:off x="3943940" y="13347180"/>
            <a:ext cx="1368000" cy="1440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2F017B3-A086-DB49-89C3-12199DF587FF}"/>
              </a:ext>
            </a:extLst>
          </p:cNvPr>
          <p:cNvSpPr txBox="1"/>
          <p:nvPr/>
        </p:nvSpPr>
        <p:spPr>
          <a:xfrm>
            <a:off x="3952567" y="13295886"/>
            <a:ext cx="13997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0.05  </a:t>
            </a:r>
            <a:r>
              <a:rPr lang="zh-TW" altLang="en-US" sz="800" dirty="0"/>
              <a:t> </a:t>
            </a:r>
            <a:r>
              <a:rPr lang="en-US" sz="800" dirty="0"/>
              <a:t>0.1  0.15  0.2   0.25 </a:t>
            </a:r>
            <a:r>
              <a:rPr lang="zh-TW" altLang="en-US" sz="800" dirty="0"/>
              <a:t> </a:t>
            </a:r>
            <a:r>
              <a:rPr lang="en-US" sz="800" dirty="0"/>
              <a:t> 0.3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0B42BAD-24D7-B14C-A8D0-7CC61874609D}"/>
              </a:ext>
            </a:extLst>
          </p:cNvPr>
          <p:cNvSpPr txBox="1"/>
          <p:nvPr/>
        </p:nvSpPr>
        <p:spPr>
          <a:xfrm>
            <a:off x="399709" y="1325247"/>
            <a:ext cx="2632003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600" b="1" dirty="0"/>
              <a:t>9-days-old larvae 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B64DE75-3776-8B44-A7D6-EAAE476E1673}"/>
              </a:ext>
            </a:extLst>
          </p:cNvPr>
          <p:cNvSpPr txBox="1"/>
          <p:nvPr/>
        </p:nvSpPr>
        <p:spPr>
          <a:xfrm>
            <a:off x="6190615" y="1325247"/>
            <a:ext cx="2495683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600" b="1" dirty="0"/>
              <a:t>0-day-old adults 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9BF62D3-0A6C-B546-BF2D-46593FB7A98F}"/>
              </a:ext>
            </a:extLst>
          </p:cNvPr>
          <p:cNvSpPr txBox="1"/>
          <p:nvPr/>
        </p:nvSpPr>
        <p:spPr>
          <a:xfrm>
            <a:off x="399709" y="7684483"/>
            <a:ext cx="2707664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600" b="1" dirty="0"/>
              <a:t>7-days-old adults  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E0C131B-240D-3B45-9FDB-AA9296E4BCEB}"/>
              </a:ext>
            </a:extLst>
          </p:cNvPr>
          <p:cNvSpPr txBox="1"/>
          <p:nvPr/>
        </p:nvSpPr>
        <p:spPr>
          <a:xfrm>
            <a:off x="6190615" y="7684483"/>
            <a:ext cx="2800638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600" b="1" dirty="0"/>
              <a:t>14-days-old adults 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01E3023-0504-694F-820B-A2BF4CA068E1}"/>
              </a:ext>
            </a:extLst>
          </p:cNvPr>
          <p:cNvSpPr txBox="1"/>
          <p:nvPr/>
        </p:nvSpPr>
        <p:spPr>
          <a:xfrm>
            <a:off x="-6171" y="488674"/>
            <a:ext cx="42672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6181726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C458350F-D5CC-8D46-9119-B716E280D6D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81529" y="1736723"/>
            <a:ext cx="5760000" cy="57600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A9182E44-F3F9-CF4B-A3F1-8EA0B1865BE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8785" y="1736723"/>
            <a:ext cx="5760000" cy="57600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C9A0D1DC-902E-034F-95EF-D0AFD767D5F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8785" y="8137523"/>
            <a:ext cx="5760000" cy="57600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E321EDB-EFDE-CC49-8B42-ED54F59FFA9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281529" y="8137523"/>
            <a:ext cx="5760000" cy="5760000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6F082485-B1F6-4E4B-8531-95FF42003323}"/>
              </a:ext>
            </a:extLst>
          </p:cNvPr>
          <p:cNvSpPr txBox="1"/>
          <p:nvPr/>
        </p:nvSpPr>
        <p:spPr>
          <a:xfrm>
            <a:off x="399709" y="1325247"/>
            <a:ext cx="2632003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600" b="1" dirty="0"/>
              <a:t>9-days-old larvae 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943D392-C484-DA4D-90F9-626852C6D592}"/>
              </a:ext>
            </a:extLst>
          </p:cNvPr>
          <p:cNvSpPr txBox="1"/>
          <p:nvPr/>
        </p:nvSpPr>
        <p:spPr>
          <a:xfrm>
            <a:off x="6190615" y="1325247"/>
            <a:ext cx="2495683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600" b="1" dirty="0"/>
              <a:t>0-day-old adults 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C348D86-8810-5644-938A-65372243548F}"/>
              </a:ext>
            </a:extLst>
          </p:cNvPr>
          <p:cNvSpPr txBox="1"/>
          <p:nvPr/>
        </p:nvSpPr>
        <p:spPr>
          <a:xfrm>
            <a:off x="399709" y="7684483"/>
            <a:ext cx="2707664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600" b="1" dirty="0"/>
              <a:t>7-days-old adults 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5E94D88-F82C-DA4D-BE45-695608859AF3}"/>
              </a:ext>
            </a:extLst>
          </p:cNvPr>
          <p:cNvSpPr txBox="1"/>
          <p:nvPr/>
        </p:nvSpPr>
        <p:spPr>
          <a:xfrm>
            <a:off x="6190615" y="7684483"/>
            <a:ext cx="2800638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600" b="1" dirty="0"/>
              <a:t>14-days-old adults 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A6944B2-6D02-9140-997B-BB80815BAE68}"/>
              </a:ext>
            </a:extLst>
          </p:cNvPr>
          <p:cNvSpPr txBox="1"/>
          <p:nvPr/>
        </p:nvSpPr>
        <p:spPr>
          <a:xfrm>
            <a:off x="-6171" y="488674"/>
            <a:ext cx="40588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dirty="0"/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370791765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4">
            <a:extLst>
              <a:ext uri="{FF2B5EF4-FFF2-40B4-BE49-F238E27FC236}">
                <a16:creationId xmlns:a16="http://schemas.microsoft.com/office/drawing/2014/main" id="{6C92D089-8647-FD42-96E6-23D5A775BD3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53716" y="1721525"/>
            <a:ext cx="5760000" cy="57600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62306846-0B02-DD4D-BB11-9709B5A19C1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8785" y="8097141"/>
            <a:ext cx="5760000" cy="57600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095DABDF-D84E-7B46-9FDE-4810A7415BC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8785" y="1721525"/>
            <a:ext cx="5760000" cy="57600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0A40138-D826-BA4E-989E-C2D76BEE833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253716" y="8097141"/>
            <a:ext cx="5760000" cy="576000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13BA34BE-7B52-5A47-8160-E006D0D3A0B9}"/>
              </a:ext>
            </a:extLst>
          </p:cNvPr>
          <p:cNvSpPr txBox="1"/>
          <p:nvPr/>
        </p:nvSpPr>
        <p:spPr>
          <a:xfrm>
            <a:off x="658090" y="14131636"/>
            <a:ext cx="10931237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/>
              <a:t>Supplementary Figure S2 </a:t>
            </a:r>
            <a:r>
              <a:rPr lang="en-US" sz="2400" dirty="0"/>
              <a:t>Enriched directed GO terms connection in the pool of a. up-regulated and b. down-regulated DEGs among different imidacloprid treatments at 9-days-old larvae, 0-day-old adults, 7-days-old adults, and 14-days-old adults. Size: the numbers of DEGs; </a:t>
            </a:r>
            <a:r>
              <a:rPr lang="en-US" sz="2400" dirty="0" err="1"/>
              <a:t>pvalue</a:t>
            </a:r>
            <a:r>
              <a:rPr lang="en-US" sz="2400" dirty="0"/>
              <a:t>: the p value of identified GO terms, the color from red to blue representing the p value from low to high.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C4FEE33-9C4A-734D-A484-65DB8CA1C035}"/>
              </a:ext>
            </a:extLst>
          </p:cNvPr>
          <p:cNvSpPr txBox="1"/>
          <p:nvPr/>
        </p:nvSpPr>
        <p:spPr>
          <a:xfrm>
            <a:off x="399709" y="1325247"/>
            <a:ext cx="2632003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600" b="1" dirty="0"/>
              <a:t>9-days-old larvae 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115EA35-9EC9-694C-B68E-768F70CFB220}"/>
              </a:ext>
            </a:extLst>
          </p:cNvPr>
          <p:cNvSpPr txBox="1"/>
          <p:nvPr/>
        </p:nvSpPr>
        <p:spPr>
          <a:xfrm>
            <a:off x="6190615" y="1325247"/>
            <a:ext cx="2495683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600" b="1" dirty="0"/>
              <a:t>0-day-old adults 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F0D1EBE-FEFF-B340-A731-251E3A6458AD}"/>
              </a:ext>
            </a:extLst>
          </p:cNvPr>
          <p:cNvSpPr txBox="1"/>
          <p:nvPr/>
        </p:nvSpPr>
        <p:spPr>
          <a:xfrm>
            <a:off x="399709" y="7684483"/>
            <a:ext cx="2707664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600" b="1" dirty="0"/>
              <a:t>7-days-old adults 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5CEFED6-2428-0F42-9AE5-A2944AFB9D9F}"/>
              </a:ext>
            </a:extLst>
          </p:cNvPr>
          <p:cNvSpPr txBox="1"/>
          <p:nvPr/>
        </p:nvSpPr>
        <p:spPr>
          <a:xfrm>
            <a:off x="6190615" y="7684483"/>
            <a:ext cx="2800638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600" b="1" dirty="0"/>
              <a:t>14-days-old adults 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8BEC09A-4F32-074B-ACDB-03BE4BE48DC6}"/>
              </a:ext>
            </a:extLst>
          </p:cNvPr>
          <p:cNvSpPr txBox="1"/>
          <p:nvPr/>
        </p:nvSpPr>
        <p:spPr>
          <a:xfrm>
            <a:off x="-6171" y="488674"/>
            <a:ext cx="42672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3158739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10</TotalTime>
  <Words>189</Words>
  <Application>Microsoft Office PowerPoint</Application>
  <PresentationFormat>Custom</PresentationFormat>
  <Paragraphs>24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新細明體</vt:lpstr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DPI</cp:lastModifiedBy>
  <cp:revision>54</cp:revision>
  <dcterms:created xsi:type="dcterms:W3CDTF">2021-09-06T02:28:59Z</dcterms:created>
  <dcterms:modified xsi:type="dcterms:W3CDTF">2021-10-31T10:34:22Z</dcterms:modified>
</cp:coreProperties>
</file>